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6DDAF6-98CE-4658-8F3C-F4855CD804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376E19-90E5-42AA-956B-59AC984438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67F21B-EC64-44E0-AD69-ED3797D393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96ECDF-E369-4D2D-84A1-4EC90B86BC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7D6FC1-B3B5-4ED0-8480-E29096B68E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23FE5-5E15-4302-8A02-7EC5EC822D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3AC63-166F-45CF-BE65-2C47143AD7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91FE7-7045-4693-A268-A25F58C836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3A05F-F0A3-4077-AD53-F25DEE189E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17EF1-698B-471E-AC48-D625BF9E67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288F7-A7E4-46B3-AE18-E96C1462D1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F862B2-4FE0-40DD-8509-23DBE179CB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37AC78-5F75-42B6-988D-EB72AB7FB5FF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4200" y="857160"/>
          <a:ext cx="8786880" cy="5440320"/>
        </p:xfrm>
        <a:graphic>
          <a:graphicData uri="http://schemas.openxmlformats.org/drawingml/2006/table">
            <a:tbl>
              <a:tblPr/>
              <a:tblGrid>
                <a:gridCol w="1416240"/>
                <a:gridCol w="1558800"/>
                <a:gridCol w="946080"/>
                <a:gridCol w="722520"/>
                <a:gridCol w="615960"/>
                <a:gridCol w="785880"/>
                <a:gridCol w="2287440"/>
                <a:gridCol w="453960"/>
              </a:tblGrid>
              <a:tr h="541440"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en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unc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ut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fere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im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Kind of Prim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→`3`Orient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Base lengt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3180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ndothelial Nitric Oxide Synth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Nos 4a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duction of nitric oxide (NO);  regulation of vasomotor tone and anti thrombotic ac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sertion / Deletion of tandem repeat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5,6,16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NOS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eNOS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ÀGGCCCTATGGTAGTGCCT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CTGCTACTGACAGCACC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olipoprotein 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o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olymorph protein; component of chylomicrons and VLDL lipoprotein remnants as well as ligands for LDL recepto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12 C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58 C 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4,7,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3,14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oE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oE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CTGTCCAAGGAGCTGCAGGCGGTGCAGGCCCGGCTGGGT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TCGCGGGCCCCGGCCTGGT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epatic Lip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LIP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tor of lipid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2 C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7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L 5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L 5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CTTTCCCATTAGGGCTGGA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ATTCTCACCATTGAAGCCGT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holesteryl Ester Transfer Prote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T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ediator of lipid metabolismus (HDL and Lipoprotein B) and regulates HDL plasma level and size of HDL molecul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629 C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9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TP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ETP-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TCTGGTCACAGTTGCTGCA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TAGACTTTCCTTGATATGCATAAAATACCACTGG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212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lasminogen Activator Inhibitor 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AI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hibition of conversion of plasmin to plasminoge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uanin inser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4G-668/5G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6,10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AI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AI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GCCCTCAGGGGCACAGA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AGTCTGGCCACG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CTAGGTTTTGTCTGTCTAGG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TTGGGGC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720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ctivated Protein C Resistanc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nactivation of Factor Va mediated by activated protein C.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1691 G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8,11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C-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APC-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AACAACACCATGATCAGAGC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TAGCCAGGAGACCTAACATGTT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61760">
                <a:tc>
                  <a:txBody>
                    <a:bodyPr lIns="36000" rIns="360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rothrombin, Mutatio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nversion to thromb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0210 G 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Wingdings"/>
                          <a:ea typeface="Wingdings"/>
                        </a:rPr>
                        <a:t></a:t>
                      </a: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[12]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T-2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PT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Forwar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ver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AGAGAGCTGCCCATGAATAGCACTGGGAGCATTGAA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GGCTGTGACCGGGATGGGAAATATGG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0" rIns="3600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36000" marR="36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0T16:11:02Z</dcterms:created>
  <dc:creator>Dr. Eifert</dc:creator>
  <dc:description/>
  <dc:language>en-US</dc:language>
  <cp:lastModifiedBy>BMC</cp:lastModifiedBy>
  <dcterms:modified xsi:type="dcterms:W3CDTF">2009-08-13T14:44:37Z</dcterms:modified>
  <cp:revision>3</cp:revision>
  <dc:subject/>
  <dc:title>Folie 1</dc:title>
</cp:coreProperties>
</file>